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600"/>
    <a:srgbClr val="797979"/>
    <a:srgbClr val="009193"/>
    <a:srgbClr val="929000"/>
    <a:srgbClr val="76D6FF"/>
    <a:srgbClr val="521B93"/>
    <a:srgbClr val="941651"/>
    <a:srgbClr val="D5FC79"/>
    <a:srgbClr val="942093"/>
    <a:srgbClr val="0054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1707"/>
    <p:restoredTop sz="94650"/>
  </p:normalViewPr>
  <p:slideViewPr>
    <p:cSldViewPr snapToGrid="0" snapToObjects="1">
      <p:cViewPr>
        <p:scale>
          <a:sx n="92" d="100"/>
          <a:sy n="92" d="100"/>
        </p:scale>
        <p:origin x="328" y="7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usanneghandili2/Desktop/Forschung/Manuskripte/Myelome%20/VdT-PACE/Datenbanken/PACE%20Datenbank_28_03_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autoTitleDeleted val="1"/>
    <c:plotArea>
      <c:layout/>
      <c:ofPieChart>
        <c:ofPieType val="pie"/>
        <c:varyColors val="1"/>
        <c:ser>
          <c:idx val="0"/>
          <c:order val="0"/>
          <c:dPt>
            <c:idx val="0"/>
            <c:bubble3D val="0"/>
            <c:spPr>
              <a:solidFill>
                <a:srgbClr val="00919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F5E-8C4F-8B32-027C568EF217}"/>
              </c:ext>
            </c:extLst>
          </c:dPt>
          <c:dPt>
            <c:idx val="1"/>
            <c:bubble3D val="0"/>
            <c:spPr>
              <a:solidFill>
                <a:srgbClr val="FF416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F5E-8C4F-8B32-027C568EF217}"/>
              </c:ext>
            </c:extLst>
          </c:dPt>
          <c:dPt>
            <c:idx val="2"/>
            <c:bubble3D val="0"/>
            <c:spPr>
              <a:solidFill>
                <a:srgbClr val="00B0F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F5E-8C4F-8B32-027C568EF217}"/>
              </c:ext>
            </c:extLst>
          </c:dPt>
          <c:dPt>
            <c:idx val="3"/>
            <c:bubble3D val="0"/>
            <c:spPr>
              <a:solidFill>
                <a:srgbClr val="76D6FF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F5E-8C4F-8B32-027C568EF217}"/>
              </c:ext>
            </c:extLst>
          </c:dPt>
          <c:dPt>
            <c:idx val="4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F5E-8C4F-8B32-027C568EF217}"/>
              </c:ext>
            </c:extLst>
          </c:dPt>
          <c:dPt>
            <c:idx val="5"/>
            <c:bubble3D val="0"/>
            <c:spPr>
              <a:solidFill>
                <a:srgbClr val="929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F5E-8C4F-8B32-027C568EF217}"/>
              </c:ext>
            </c:extLst>
          </c:dPt>
          <c:dPt>
            <c:idx val="6"/>
            <c:bubble3D val="0"/>
            <c:spPr>
              <a:solidFill>
                <a:srgbClr val="FFC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F5E-8C4F-8B32-027C568EF217}"/>
              </c:ext>
            </c:extLst>
          </c:dPt>
          <c:dPt>
            <c:idx val="7"/>
            <c:bubble3D val="0"/>
            <c:spPr>
              <a:solidFill>
                <a:schemeClr val="bg1">
                  <a:lumMod val="75000"/>
                  <a:alpha val="61176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8F5E-8C4F-8B32-027C568EF217}"/>
              </c:ext>
            </c:extLst>
          </c:dPt>
          <c:dLbls>
            <c:dLbl>
              <c:idx val="5"/>
              <c:layout>
                <c:manualLayout>
                  <c:x val="-8.0100594995346705E-3"/>
                  <c:y val="-1.841920575145499E-2"/>
                </c:manualLayout>
              </c:layout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8F5E-8C4F-8B32-027C568EF217}"/>
                </c:ext>
              </c:extLst>
            </c:dLbl>
            <c:dLbl>
              <c:idx val="6"/>
              <c:layout>
                <c:manualLayout>
                  <c:x val="2.2987943240162709E-2"/>
                  <c:y val="-1.3063591235878124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400" b="1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de-DE"/>
                </a:p>
              </c:txPr>
              <c:dLblPos val="bestFit"/>
              <c:showLegendKey val="0"/>
              <c:showVal val="0"/>
              <c:showCatName val="0"/>
              <c:showSerName val="0"/>
              <c:showPercent val="1"/>
              <c:showBubbleSize val="0"/>
              <c:separator>, </c:separator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8F5E-8C4F-8B32-027C568EF21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inEnd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Tabelle2!$A$2:$A$8</c:f>
              <c:strCache>
                <c:ptCount val="7"/>
                <c:pt idx="0">
                  <c:v>Neutropenia</c:v>
                </c:pt>
                <c:pt idx="1">
                  <c:v>Lymphocytopenia</c:v>
                </c:pt>
                <c:pt idx="2">
                  <c:v>Thrombpenia </c:v>
                </c:pt>
                <c:pt idx="3">
                  <c:v>Bleeding </c:v>
                </c:pt>
                <c:pt idx="4">
                  <c:v>Infections</c:v>
                </c:pt>
                <c:pt idx="5">
                  <c:v>Emesis</c:v>
                </c:pt>
                <c:pt idx="6">
                  <c:v>Enoral mucositis </c:v>
                </c:pt>
              </c:strCache>
            </c:strRef>
          </c:cat>
          <c:val>
            <c:numRef>
              <c:f>Tabelle2!$B$2:$B$8</c:f>
              <c:numCache>
                <c:formatCode>General</c:formatCode>
                <c:ptCount val="7"/>
                <c:pt idx="0">
                  <c:v>45</c:v>
                </c:pt>
                <c:pt idx="1">
                  <c:v>42</c:v>
                </c:pt>
                <c:pt idx="2">
                  <c:v>46</c:v>
                </c:pt>
                <c:pt idx="3">
                  <c:v>7</c:v>
                </c:pt>
                <c:pt idx="4">
                  <c:v>29</c:v>
                </c:pt>
                <c:pt idx="5">
                  <c:v>2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8F5E-8C4F-8B32-027C568EF217}"/>
            </c:ext>
          </c:extLst>
        </c:ser>
        <c:dLbls>
          <c:dLblPos val="in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gapWidth val="100"/>
        <c:splitType val="cust"/>
        <c:custSplit>
          <c:secondPiePt val="0"/>
          <c:secondPiePt val="1"/>
          <c:secondPiePt val="2"/>
        </c:custSplit>
        <c:secondPieSize val="75"/>
        <c:serLines>
          <c:spPr>
            <a:ln w="9525" cap="flat" cmpd="sng" algn="ctr">
              <a:solidFill>
                <a:schemeClr val="tx1">
                  <a:lumMod val="35000"/>
                  <a:lumOff val="65000"/>
                </a:schemeClr>
              </a:solidFill>
              <a:round/>
            </a:ln>
            <a:effectLst/>
          </c:spPr>
        </c:serLines>
      </c:of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4">
  <a:schemeClr val="accent4"/>
</cs:colorStyle>
</file>

<file path=ppt/charts/style1.xml><?xml version="1.0" encoding="utf-8"?>
<cs:chartStyle xmlns:cs="http://schemas.microsoft.com/office/drawing/2012/chartStyle" xmlns:a="http://schemas.openxmlformats.org/drawingml/2006/main" id="33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50000"/>
            <a:lumOff val="50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4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7852DC-B485-8B4F-B5E7-41508839046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D1EEAE-4ADE-6A4F-9022-57139B306E1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9065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677340-96B9-2D49-9D99-C5513390F3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A021DA5-E47D-064D-812B-474D79B099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A269CD3-0461-3F4F-9D32-733F8E5F7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A6117A9-78E9-724B-A93D-B15FEE6623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F234830-90DB-0A45-A060-8D2835DF6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739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BC953F-DD51-CA49-9FD1-D92E3F20EE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F29868D-6C64-904A-A5A7-E238F23D62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C4FCAB3-FA63-EB48-8A7A-535B4EB59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AFE4131-227D-F847-A869-19FAC6500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28F0B7E-6050-AB4F-9DCC-D8B0BC50A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56907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A3A670C-E651-8748-ABEE-7568B48C3B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0427F4FC-B773-9F4A-B8BC-022CD7BE95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9B02C2C-8B9C-6B4E-9F5C-EE3CF2D2A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119FD8F-C2BF-B34D-B59F-C23C8F3D2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25228A4-3276-3548-A753-D8698A6F3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9389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56F928-FA9F-CE4C-9FC3-9AF0387CA1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CAAF184-1F0A-AC40-8090-B31AF83E33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69D834D-297A-FA4D-910C-991D60F32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9934697-095F-1042-92A1-475908545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A1DEEB9-B991-6644-9B94-4A610738AD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01557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1091082-83C4-2747-8911-26451028F0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54AB065-24BD-C14C-B81E-9BCC406C67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CA4BB9F-B6CC-FD48-8A95-7A4C032C6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2E12E9F-0F90-E54C-9BE8-4098717F1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0F39DB4-A95E-B04C-B7B0-13ADED3D3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7104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4340E17-F598-DA4C-AFD2-B2FBA5B004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6909D83-65F5-4F4C-929E-8FB219C030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B23453C-7D3E-1744-A8D0-8C8FCBB0BC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BCF8260-FFA3-F14F-90FE-F5BF4BE5D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C1969D6-AE76-BD4B-A451-D4A861E31C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7241780-5074-F34F-9A94-052F7A3B3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1538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E4A00A0-FE1C-B04C-AD57-62C2D791AD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8224DFA-6425-7342-9222-A0A8944379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2E1FE5A-B3F9-F540-A8E9-BEA3470320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3FACA52-0FB4-F64E-8CEB-CE721FFE28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01C4EDA6-F00A-7241-A726-881A471D68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319F9792-1013-ED41-9E51-C3AF4BDC7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940021D-7D5F-A34C-BC3A-4A0639BCD3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3143A026-3145-DF41-8F16-CDA7D363C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68424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4C85C0-A769-5F46-B1FE-599B379773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7AA0DBD-3511-C84D-A25A-7CBC65310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A3481CDB-7EC7-144A-838C-1CD35F98F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AF38C13-6107-4145-9C39-6F9A33FB44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8401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46E4DF28-B1AC-224D-B017-FA60F79A0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5C15B4B1-8627-DD4B-9B98-1F43394A0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8B07174-2161-EF4A-AF44-890C5E349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4871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DA435B-C5D8-8743-BB7F-55D2A145B1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BA52DB2-32B1-E64E-852C-BB907F4F704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CD7DC59-E517-BF44-9CCB-6AABD9F485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0F6AB64-0CBF-924B-A7B5-C26C413D8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F74DC2C-F439-B345-AC9F-FE7710366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3A2B81D-C207-E542-B362-FDD79CBB0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8487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A8FDD6-B3E4-D745-BA6B-4DA7A23F65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D70F4C1-7BEB-4849-909E-4ECD8F333D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D06F365-882F-F54D-BE11-75EA053695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D74A329-AE5F-0143-B7C2-8F999F81E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F820DE3-0E12-F247-9CF8-8D12401C0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7CE9A36-A02E-9840-9073-F116CE8AD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0717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D1183D06-64E0-8A4F-9D71-4EC2528B7C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F8C66EC-283C-EA40-9718-05E710F365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68FBB12-00EB-DA4F-BE8B-7929606752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C6B4F-EE49-6B48-BF16-7A8CF4B92B5C}" type="datetimeFigureOut">
              <a:rPr lang="de-DE" smtClean="0"/>
              <a:t>11.08.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A5B093A-5CC7-2946-94FF-8B5A2AD4F0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F3F6C6F-C99A-E844-9A43-E495B6BB0A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B597D7-D8CA-A448-89DF-AE7ADF35443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4881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>
            <a:extLst>
              <a:ext uri="{FF2B5EF4-FFF2-40B4-BE49-F238E27FC236}">
                <a16:creationId xmlns:a16="http://schemas.microsoft.com/office/drawing/2014/main" id="{CBEAC410-6806-C64E-B80A-38A66AB1FF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4749660"/>
              </p:ext>
            </p:extLst>
          </p:nvPr>
        </p:nvGraphicFramePr>
        <p:xfrm>
          <a:off x="2410692" y="1279521"/>
          <a:ext cx="7861589" cy="34239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AF676970-B79C-364B-ABD5-1777922467E3}"/>
              </a:ext>
            </a:extLst>
          </p:cNvPr>
          <p:cNvSpPr txBox="1"/>
          <p:nvPr/>
        </p:nvSpPr>
        <p:spPr>
          <a:xfrm>
            <a:off x="7638185" y="4703476"/>
            <a:ext cx="21431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/>
              <a:t>Hematological </a:t>
            </a:r>
          </a:p>
          <a:p>
            <a:pPr algn="ctr"/>
            <a:r>
              <a:rPr lang="de-DE" sz="1600" b="1" dirty="0"/>
              <a:t>adverse events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F8F4718B-BC06-9045-A789-EA345F72842B}"/>
              </a:ext>
            </a:extLst>
          </p:cNvPr>
          <p:cNvSpPr txBox="1"/>
          <p:nvPr/>
        </p:nvSpPr>
        <p:spPr>
          <a:xfrm>
            <a:off x="3138922" y="4703477"/>
            <a:ext cx="21431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/>
              <a:t>All grade 3/4 </a:t>
            </a:r>
          </a:p>
          <a:p>
            <a:pPr algn="ctr"/>
            <a:r>
              <a:rPr lang="de-DE" sz="1600" b="1" dirty="0"/>
              <a:t>adverse events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02F770E3-2BD4-9746-BCB4-8481EE8EA1DD}"/>
              </a:ext>
            </a:extLst>
          </p:cNvPr>
          <p:cNvSpPr txBox="1"/>
          <p:nvPr/>
        </p:nvSpPr>
        <p:spPr>
          <a:xfrm>
            <a:off x="429492" y="2267166"/>
            <a:ext cx="1981200" cy="1448666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200" dirty="0">
                <a:cs typeface="Arial" panose="020B0604020202020204" pitchFamily="34" charset="0"/>
              </a:rPr>
              <a:t>Total </a:t>
            </a:r>
            <a:r>
              <a:rPr lang="de-DE" sz="1200" dirty="0" err="1">
                <a:cs typeface="Arial" panose="020B0604020202020204" pitchFamily="34" charset="0"/>
              </a:rPr>
              <a:t>hematological</a:t>
            </a:r>
            <a:r>
              <a:rPr lang="de-DE" sz="1200" dirty="0">
                <a:cs typeface="Arial" panose="020B0604020202020204" pitchFamily="34" charset="0"/>
              </a:rPr>
              <a:t> AEs       </a:t>
            </a:r>
          </a:p>
          <a:p>
            <a:pPr>
              <a:lnSpc>
                <a:spcPct val="150000"/>
              </a:lnSpc>
            </a:pPr>
            <a:r>
              <a:rPr lang="de-DE" sz="1200" dirty="0" err="1">
                <a:cs typeface="Arial" panose="020B0604020202020204" pitchFamily="34" charset="0"/>
              </a:rPr>
              <a:t>Bleeding</a:t>
            </a:r>
            <a:r>
              <a:rPr lang="de-DE" sz="1200" dirty="0">
                <a:cs typeface="Arial" panose="020B0604020202020204" pitchFamily="34" charset="0"/>
              </a:rPr>
              <a:t>  </a:t>
            </a:r>
            <a:r>
              <a:rPr lang="de-DE" sz="1200" dirty="0" err="1">
                <a:cs typeface="Arial" panose="020B0604020202020204" pitchFamily="34" charset="0"/>
              </a:rPr>
              <a:t>events</a:t>
            </a:r>
            <a:r>
              <a:rPr lang="de-DE" sz="1200" dirty="0">
                <a:cs typeface="Arial" panose="020B0604020202020204" pitchFamily="34" charset="0"/>
              </a:rPr>
              <a:t>     </a:t>
            </a:r>
          </a:p>
          <a:p>
            <a:pPr>
              <a:lnSpc>
                <a:spcPct val="150000"/>
              </a:lnSpc>
            </a:pPr>
            <a:r>
              <a:rPr lang="de-DE" sz="1200" dirty="0" err="1">
                <a:cs typeface="Arial" panose="020B0604020202020204" pitchFamily="34" charset="0"/>
              </a:rPr>
              <a:t>Infections</a:t>
            </a:r>
            <a:endParaRPr lang="de-DE" sz="1200" dirty="0"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de-DE" sz="1200" dirty="0" err="1">
                <a:cs typeface="Arial" panose="020B0604020202020204" pitchFamily="34" charset="0"/>
              </a:rPr>
              <a:t>Emesis</a:t>
            </a:r>
            <a:endParaRPr lang="de-DE" sz="1200" dirty="0"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de-DE" sz="1200" dirty="0" err="1">
                <a:cs typeface="Arial" panose="020B0604020202020204" pitchFamily="34" charset="0"/>
              </a:rPr>
              <a:t>Enoral</a:t>
            </a:r>
            <a:r>
              <a:rPr lang="de-DE" sz="1200" dirty="0">
                <a:cs typeface="Arial" panose="020B0604020202020204" pitchFamily="34" charset="0"/>
              </a:rPr>
              <a:t> </a:t>
            </a:r>
            <a:r>
              <a:rPr lang="de-DE" sz="1200" dirty="0" err="1">
                <a:cs typeface="Arial" panose="020B0604020202020204" pitchFamily="34" charset="0"/>
              </a:rPr>
              <a:t>mucositis</a:t>
            </a:r>
            <a:endParaRPr lang="de-DE" sz="1200" dirty="0">
              <a:cs typeface="Arial" panose="020B0604020202020204" pitchFamily="34" charset="0"/>
            </a:endParaRP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1601D794-A573-9847-AEFD-0F83F9FDD149}"/>
              </a:ext>
            </a:extLst>
          </p:cNvPr>
          <p:cNvSpPr/>
          <p:nvPr/>
        </p:nvSpPr>
        <p:spPr>
          <a:xfrm>
            <a:off x="2169530" y="2378407"/>
            <a:ext cx="144000" cy="144000"/>
          </a:xfrm>
          <a:prstGeom prst="ellipse">
            <a:avLst/>
          </a:prstGeom>
          <a:solidFill>
            <a:schemeClr val="bg2">
              <a:lumMod val="90000"/>
            </a:schemeClr>
          </a:solidFill>
          <a:ln w="63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B2870735-E1C5-5546-AC19-D8B71C3AB4D0}"/>
              </a:ext>
            </a:extLst>
          </p:cNvPr>
          <p:cNvSpPr/>
          <p:nvPr/>
        </p:nvSpPr>
        <p:spPr>
          <a:xfrm>
            <a:off x="2169529" y="2630192"/>
            <a:ext cx="144000" cy="144000"/>
          </a:xfrm>
          <a:prstGeom prst="ellipse">
            <a:avLst/>
          </a:prstGeom>
          <a:solidFill>
            <a:srgbClr val="76D6FF"/>
          </a:solidFill>
          <a:ln w="63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F31110E3-87D0-E747-8E1A-A799FAFB82E4}"/>
              </a:ext>
            </a:extLst>
          </p:cNvPr>
          <p:cNvSpPr/>
          <p:nvPr/>
        </p:nvSpPr>
        <p:spPr>
          <a:xfrm>
            <a:off x="2169529" y="2922635"/>
            <a:ext cx="144000" cy="144000"/>
          </a:xfrm>
          <a:prstGeom prst="ellipse">
            <a:avLst/>
          </a:prstGeom>
          <a:solidFill>
            <a:schemeClr val="accent6">
              <a:lumMod val="60000"/>
              <a:lumOff val="40000"/>
            </a:schemeClr>
          </a:solidFill>
          <a:ln w="635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0A6ACE9A-73F8-9D43-BD6F-A52667B99C12}"/>
              </a:ext>
            </a:extLst>
          </p:cNvPr>
          <p:cNvSpPr/>
          <p:nvPr/>
        </p:nvSpPr>
        <p:spPr>
          <a:xfrm>
            <a:off x="2169529" y="3453335"/>
            <a:ext cx="144000" cy="144000"/>
          </a:xfrm>
          <a:prstGeom prst="ellipse">
            <a:avLst/>
          </a:prstGeom>
          <a:solidFill>
            <a:srgbClr val="FFC000"/>
          </a:solidFill>
          <a:ln w="6350">
            <a:solidFill>
              <a:schemeClr val="accent4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C374A749-25A7-494D-8202-994D5C8AAFAC}"/>
              </a:ext>
            </a:extLst>
          </p:cNvPr>
          <p:cNvSpPr/>
          <p:nvPr/>
        </p:nvSpPr>
        <p:spPr>
          <a:xfrm>
            <a:off x="2169529" y="3186535"/>
            <a:ext cx="144000" cy="144000"/>
          </a:xfrm>
          <a:prstGeom prst="ellipse">
            <a:avLst/>
          </a:prstGeom>
          <a:solidFill>
            <a:srgbClr val="929000"/>
          </a:solidFill>
          <a:ln w="6350">
            <a:solidFill>
              <a:srgbClr val="929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4E8E62A8-BF54-FE4A-A992-675359FD5D23}"/>
              </a:ext>
            </a:extLst>
          </p:cNvPr>
          <p:cNvSpPr txBox="1"/>
          <p:nvPr/>
        </p:nvSpPr>
        <p:spPr>
          <a:xfrm>
            <a:off x="10246516" y="2643117"/>
            <a:ext cx="1731819" cy="894669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1200" dirty="0" err="1">
                <a:cs typeface="Arial" panose="020B0604020202020204" pitchFamily="34" charset="0"/>
              </a:rPr>
              <a:t>Neutropenia</a:t>
            </a:r>
            <a:endParaRPr lang="de-DE" sz="1200" dirty="0"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de-DE" sz="1200" dirty="0" err="1">
                <a:cs typeface="Arial" panose="020B0604020202020204" pitchFamily="34" charset="0"/>
              </a:rPr>
              <a:t>Lymphocytopenia</a:t>
            </a:r>
            <a:endParaRPr lang="de-DE" sz="1200" dirty="0"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de-DE" sz="1200" dirty="0" err="1">
                <a:cs typeface="Arial" panose="020B0604020202020204" pitchFamily="34" charset="0"/>
              </a:rPr>
              <a:t>Thrombocytopenia</a:t>
            </a:r>
            <a:endParaRPr lang="de-DE" sz="1200" dirty="0">
              <a:cs typeface="Arial" panose="020B0604020202020204" pitchFamily="34" charset="0"/>
            </a:endParaRPr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AABC24ED-11D6-F845-AAD4-86F09F41A279}"/>
              </a:ext>
            </a:extLst>
          </p:cNvPr>
          <p:cNvSpPr/>
          <p:nvPr/>
        </p:nvSpPr>
        <p:spPr>
          <a:xfrm>
            <a:off x="11743009" y="2794052"/>
            <a:ext cx="144000" cy="144000"/>
          </a:xfrm>
          <a:prstGeom prst="ellipse">
            <a:avLst/>
          </a:prstGeom>
          <a:solidFill>
            <a:srgbClr val="009193"/>
          </a:solidFill>
          <a:ln w="6350">
            <a:solidFill>
              <a:schemeClr val="accent5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D22CB6FF-9934-D54B-993D-6FBDC67DD3F5}"/>
              </a:ext>
            </a:extLst>
          </p:cNvPr>
          <p:cNvSpPr/>
          <p:nvPr/>
        </p:nvSpPr>
        <p:spPr>
          <a:xfrm>
            <a:off x="11743004" y="3057292"/>
            <a:ext cx="144000" cy="144000"/>
          </a:xfrm>
          <a:prstGeom prst="ellipse">
            <a:avLst/>
          </a:prstGeom>
          <a:solidFill>
            <a:srgbClr val="FF2600"/>
          </a:solidFill>
          <a:ln w="63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8A20CB17-6E20-B949-8423-562087F8423F}"/>
              </a:ext>
            </a:extLst>
          </p:cNvPr>
          <p:cNvSpPr/>
          <p:nvPr/>
        </p:nvSpPr>
        <p:spPr>
          <a:xfrm>
            <a:off x="11748653" y="3320532"/>
            <a:ext cx="144000" cy="144000"/>
          </a:xfrm>
          <a:prstGeom prst="ellipse">
            <a:avLst/>
          </a:prstGeom>
          <a:solidFill>
            <a:srgbClr val="00B0F0"/>
          </a:solidFill>
          <a:ln w="635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600"/>
          </a:p>
        </p:txBody>
      </p:sp>
    </p:spTree>
    <p:extLst>
      <p:ext uri="{BB962C8B-B14F-4D97-AF65-F5344CB8AC3E}">
        <p14:creationId xmlns:p14="http://schemas.microsoft.com/office/powerpoint/2010/main" val="1361776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Macintosh PowerPoint</Application>
  <PresentationFormat>Breitbild</PresentationFormat>
  <Paragraphs>1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usanne Ghandili</dc:creator>
  <cp:lastModifiedBy>Susanne Ghandili</cp:lastModifiedBy>
  <cp:revision>17</cp:revision>
  <dcterms:created xsi:type="dcterms:W3CDTF">2022-04-09T10:39:31Z</dcterms:created>
  <dcterms:modified xsi:type="dcterms:W3CDTF">2022-08-11T16:22:15Z</dcterms:modified>
</cp:coreProperties>
</file>